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2" autoAdjust="0"/>
    <p:restoredTop sz="94660"/>
  </p:normalViewPr>
  <p:slideViewPr>
    <p:cSldViewPr snapToGrid="0">
      <p:cViewPr>
        <p:scale>
          <a:sx n="100" d="100"/>
          <a:sy n="100" d="100"/>
        </p:scale>
        <p:origin x="-21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49F694-7DE3-C1B0-2B5B-7BDD44315D4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F2A98AD-3764-D469-E54F-2B6FCD18793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2D61DF-3600-D85A-E06D-6B9361FA8C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D8702-B850-463E-A4D6-2B54BE37D625}" type="datetimeFigureOut">
              <a:rPr lang="en-GB" smtClean="0"/>
              <a:t>16/0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1C027D-AD52-590C-205C-CAB3DB7133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2F1C77-89C5-C156-7C55-E6E0568218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64F07-967E-4B21-8952-8412617267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15824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15FAFE-CA15-BEBA-C36A-A6894B1555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BEB277E-8359-91DF-367F-7B69D4ECF71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F7F175-7C2E-2D04-F9F4-A5A0EB4C0B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D8702-B850-463E-A4D6-2B54BE37D625}" type="datetimeFigureOut">
              <a:rPr lang="en-GB" smtClean="0"/>
              <a:t>16/0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E24FF4-6010-8215-6572-67179F2E40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CC2D7D-97E0-1D87-338A-ED4BA69BB9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64F07-967E-4B21-8952-8412617267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85539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1DA7B6E-0985-B3AC-E132-B02F046AE47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5729D28-735E-2B73-D8F6-B8B12456F40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F31D9C-B702-AFBC-E8E3-085B2C97F2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D8702-B850-463E-A4D6-2B54BE37D625}" type="datetimeFigureOut">
              <a:rPr lang="en-GB" smtClean="0"/>
              <a:t>16/0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611C4A-10DA-AEA1-A61E-8BDD8C38FB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3453C7-24A9-012C-4AF0-7D6C4820E2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64F07-967E-4B21-8952-8412617267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54651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432996-40FE-FBFA-8D40-0A12F3E3F6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AB821C6-9D48-55A7-DC06-47F3F9E0E42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27802D-1019-2DFB-2FE8-BC7A96FD79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D8702-B850-463E-A4D6-2B54BE37D625}" type="datetimeFigureOut">
              <a:rPr lang="en-GB" smtClean="0"/>
              <a:t>16/0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CD6977-B5B0-4AA1-8FE1-00F5784262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F80D78-0650-6326-C612-DBCEC71126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64F07-967E-4B21-8952-8412617267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70258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D32144-B65C-8162-27A3-CF472D7BBB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D7C8239-AF53-5D33-2A4B-1A7E6306DC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7EFBFA-EE46-895A-CD19-2372A38B13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D8702-B850-463E-A4D6-2B54BE37D625}" type="datetimeFigureOut">
              <a:rPr lang="en-GB" smtClean="0"/>
              <a:t>16/0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A6BDA4-8F65-831D-2C10-BE27CF1AAD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3DA014-5A28-6825-4C8B-11972DFE98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64F07-967E-4B21-8952-8412617267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25292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0D9A0A-3010-1DA6-CE33-ABD628BA5C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2A7293F-31A4-D684-98F2-BFC13C7FE5B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7C4827A-3F6B-E572-DEA6-7C833E9801D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39A3E27-BD13-C408-1CB5-D8B68326F8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D8702-B850-463E-A4D6-2B54BE37D625}" type="datetimeFigureOut">
              <a:rPr lang="en-GB" smtClean="0"/>
              <a:t>16/02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B8C55B7-EBA1-B924-46F0-22D96F175E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EB93780-5A39-0804-23B5-42E069DC9C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64F07-967E-4B21-8952-8412617267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56302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FE822D-14F8-FD42-81F1-C84088EA7D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560B778-BA3D-0CB6-D015-3CC6BD39EB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9F71919-C586-7FB3-3C66-62550EA5D19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6AEE1D3-D92C-C178-23D6-0FA33EFC75E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AAFA369-F64D-ACD4-760C-C3C64289E5C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E6177F9-EBA7-0503-ED75-80DEB7C376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D8702-B850-463E-A4D6-2B54BE37D625}" type="datetimeFigureOut">
              <a:rPr lang="en-GB" smtClean="0"/>
              <a:t>16/02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A07EFB1-DDDE-5F75-0D31-90F1E4F74E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1A6118B-F6DA-409F-5575-F4DCAB7ADA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64F07-967E-4B21-8952-8412617267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73393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0EF78F-1B85-2C3A-B7C0-207FCA1890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F808E1B-2F87-D5B3-193B-6B6F117D2A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D8702-B850-463E-A4D6-2B54BE37D625}" type="datetimeFigureOut">
              <a:rPr lang="en-GB" smtClean="0"/>
              <a:t>16/02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DDEE07A-D93A-51BD-4AFE-036A42FAC7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650AA34-7199-E106-855D-13F0E03BFF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64F07-967E-4B21-8952-8412617267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44127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7CE4A92-0086-9862-2F42-F74F818D2B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D8702-B850-463E-A4D6-2B54BE37D625}" type="datetimeFigureOut">
              <a:rPr lang="en-GB" smtClean="0"/>
              <a:t>16/02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1971233-65AD-8D07-C62E-691ADB2655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E44AAD7-B9F1-A77B-27E6-DB85B760C2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64F07-967E-4B21-8952-8412617267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68583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251925-C32F-9380-7FC2-0B026AE81F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03C8FB9-8EB0-11C1-61BB-DD9454DD722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6E250F5-EA65-78B5-A2A3-2ACC2408885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E75291-F9A5-A535-2636-68C664AD2A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D8702-B850-463E-A4D6-2B54BE37D625}" type="datetimeFigureOut">
              <a:rPr lang="en-GB" smtClean="0"/>
              <a:t>16/02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D368927-31CB-31EF-98CC-2DFD50A655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E15407D-D495-7E7A-8253-61EDCACE32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64F07-967E-4B21-8952-8412617267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60584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E2C24F-3597-162F-01A9-175617132F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EE4B088-8AA7-8CBA-7E2A-5F1F211D4A8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2256DF9-39E8-F58D-F252-8693153EED3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5B2D11-AFDA-FDCC-07ED-81F72E9B59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D8702-B850-463E-A4D6-2B54BE37D625}" type="datetimeFigureOut">
              <a:rPr lang="en-GB" smtClean="0"/>
              <a:t>16/02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5A424EC-D6BF-69DF-37FB-CC3E0D7716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103D5A-654E-C64C-8CCC-DEEE9A1AC0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364F07-967E-4B21-8952-8412617267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98070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0AC653C-BE74-4F79-EC22-99794AE3DF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0779AAF-7315-1B43-BED1-D47F49D808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F8BEF5-40B5-1E33-41FA-A32F471CACC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DD8702-B850-463E-A4D6-2B54BE37D625}" type="datetimeFigureOut">
              <a:rPr lang="en-GB" smtClean="0"/>
              <a:t>16/02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8147B7-0D20-AB5F-B0E1-2582421F0CA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63AD52-2B8B-274E-2332-93DEDED29EA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364F07-967E-4B21-8952-84126172673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403050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13" Type="http://schemas.openxmlformats.org/officeDocument/2006/relationships/image" Target="../media/image9.jpeg"/><Relationship Id="rId18" Type="http://schemas.openxmlformats.org/officeDocument/2006/relationships/image" Target="../media/image14.jpeg"/><Relationship Id="rId26" Type="http://schemas.microsoft.com/office/2007/relationships/hdphoto" Target="../media/hdphoto6.wdp"/><Relationship Id="rId3" Type="http://schemas.openxmlformats.org/officeDocument/2006/relationships/image" Target="../media/image2.jpeg"/><Relationship Id="rId21" Type="http://schemas.microsoft.com/office/2007/relationships/hdphoto" Target="../media/hdphoto4.wdp"/><Relationship Id="rId7" Type="http://schemas.openxmlformats.org/officeDocument/2006/relationships/image" Target="../media/image6.jpeg"/><Relationship Id="rId12" Type="http://schemas.microsoft.com/office/2007/relationships/hdphoto" Target="../media/hdphoto3.wdp"/><Relationship Id="rId17" Type="http://schemas.openxmlformats.org/officeDocument/2006/relationships/image" Target="../media/image13.jpeg"/><Relationship Id="rId25" Type="http://schemas.openxmlformats.org/officeDocument/2006/relationships/image" Target="../media/image19.jpeg"/><Relationship Id="rId2" Type="http://schemas.openxmlformats.org/officeDocument/2006/relationships/image" Target="../media/image1.jpeg"/><Relationship Id="rId16" Type="http://schemas.openxmlformats.org/officeDocument/2006/relationships/image" Target="../media/image12.jpeg"/><Relationship Id="rId20" Type="http://schemas.openxmlformats.org/officeDocument/2006/relationships/image" Target="../media/image16.jpeg"/><Relationship Id="rId29" Type="http://schemas.openxmlformats.org/officeDocument/2006/relationships/image" Target="../media/image2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8.jpeg"/><Relationship Id="rId24" Type="http://schemas.microsoft.com/office/2007/relationships/hdphoto" Target="../media/hdphoto5.wdp"/><Relationship Id="rId5" Type="http://schemas.openxmlformats.org/officeDocument/2006/relationships/image" Target="../media/image4.jpeg"/><Relationship Id="rId15" Type="http://schemas.openxmlformats.org/officeDocument/2006/relationships/image" Target="../media/image11.jpeg"/><Relationship Id="rId23" Type="http://schemas.openxmlformats.org/officeDocument/2006/relationships/image" Target="../media/image18.jpeg"/><Relationship Id="rId28" Type="http://schemas.microsoft.com/office/2007/relationships/hdphoto" Target="../media/hdphoto7.wdp"/><Relationship Id="rId10" Type="http://schemas.microsoft.com/office/2007/relationships/hdphoto" Target="../media/hdphoto2.wdp"/><Relationship Id="rId19" Type="http://schemas.openxmlformats.org/officeDocument/2006/relationships/image" Target="../media/image15.jpeg"/><Relationship Id="rId4" Type="http://schemas.openxmlformats.org/officeDocument/2006/relationships/image" Target="../media/image3.jpeg"/><Relationship Id="rId9" Type="http://schemas.openxmlformats.org/officeDocument/2006/relationships/image" Target="../media/image7.jpeg"/><Relationship Id="rId14" Type="http://schemas.openxmlformats.org/officeDocument/2006/relationships/image" Target="../media/image10.jpeg"/><Relationship Id="rId22" Type="http://schemas.openxmlformats.org/officeDocument/2006/relationships/image" Target="../media/image17.jpeg"/><Relationship Id="rId27" Type="http://schemas.openxmlformats.org/officeDocument/2006/relationships/image" Target="../media/image20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C:\Users\USER\CloudStation\project\Thanh\5. PLOS One\erratum\A5(Fc1)1j.jpg">
            <a:extLst>
              <a:ext uri="{FF2B5EF4-FFF2-40B4-BE49-F238E27FC236}">
                <a16:creationId xmlns:a16="http://schemas.microsoft.com/office/drawing/2014/main" id="{C7CF73CF-4B65-4B6A-AEA3-92B11AA3E81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86743" y="1320300"/>
            <a:ext cx="952500" cy="7143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A71F39AC-CB55-44CF-B772-A059154A1BD5}"/>
              </a:ext>
            </a:extLst>
          </p:cNvPr>
          <p:cNvSpPr txBox="1"/>
          <p:nvPr/>
        </p:nvSpPr>
        <p:spPr>
          <a:xfrm>
            <a:off x="900062" y="970145"/>
            <a:ext cx="452521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>
                <a:latin typeface="Times New Roman" pitchFamily="18" charset="0"/>
                <a:cs typeface="Times New Roman" pitchFamily="18" charset="0"/>
              </a:rPr>
              <a:t>DMSO     </a:t>
            </a:r>
            <a:r>
              <a:rPr lang="en-US" altLang="ko-KR" sz="1600" i="1" dirty="0" err="1">
                <a:latin typeface="Times New Roman" pitchFamily="18" charset="0"/>
                <a:cs typeface="Times New Roman" pitchFamily="18" charset="0"/>
              </a:rPr>
              <a:t>F.cucullata</a:t>
            </a:r>
            <a:r>
              <a:rPr lang="en-US" altLang="ko-KR" sz="1600" dirty="0"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US" altLang="ko-KR" sz="1600" dirty="0" err="1">
                <a:latin typeface="Times New Roman" pitchFamily="18" charset="0"/>
                <a:cs typeface="Times New Roman" pitchFamily="18" charset="0"/>
              </a:rPr>
              <a:t>Usnic</a:t>
            </a:r>
            <a:r>
              <a:rPr lang="en-US" altLang="ko-KR" sz="1600" dirty="0">
                <a:latin typeface="Times New Roman" pitchFamily="18" charset="0"/>
                <a:cs typeface="Times New Roman" pitchFamily="18" charset="0"/>
              </a:rPr>
              <a:t> acid   </a:t>
            </a:r>
            <a:r>
              <a:rPr lang="en-US" altLang="ko-KR" sz="1600" dirty="0" err="1">
                <a:latin typeface="Times New Roman" pitchFamily="18" charset="0"/>
                <a:cs typeface="Times New Roman" pitchFamily="18" charset="0"/>
              </a:rPr>
              <a:t>Lichesterinic</a:t>
            </a:r>
            <a:r>
              <a:rPr lang="en-US" altLang="ko-KR" sz="1600" dirty="0">
                <a:latin typeface="Times New Roman" pitchFamily="18" charset="0"/>
                <a:cs typeface="Times New Roman" pitchFamily="18" charset="0"/>
              </a:rPr>
              <a:t> acid</a:t>
            </a:r>
            <a:endParaRPr lang="ko-KR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" name="Picture 3" descr="C:\Users\USER\CloudStation\project\Thanh\5. PLOS One\erratum\A5(Fc1)2j.jpg">
            <a:extLst>
              <a:ext uri="{FF2B5EF4-FFF2-40B4-BE49-F238E27FC236}">
                <a16:creationId xmlns:a16="http://schemas.microsoft.com/office/drawing/2014/main" id="{483D92E3-0E6E-49D3-BDB9-0CE156F4D44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86743" y="2095417"/>
            <a:ext cx="952500" cy="7143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 descr="C:\Users\USER\CloudStation\project\Thanh\5. PLOS One\erratum\A5(Fc1)4j.jpg">
            <a:extLst>
              <a:ext uri="{FF2B5EF4-FFF2-40B4-BE49-F238E27FC236}">
                <a16:creationId xmlns:a16="http://schemas.microsoft.com/office/drawing/2014/main" id="{32C9627B-FC13-4AFF-9986-25ED9F50B26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86743" y="2862838"/>
            <a:ext cx="952500" cy="7143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5" descr="C:\Users\USER\CloudStation\project\Thanh\5. PLOS One\erratum\A5(Fc1)5j.jpg">
            <a:extLst>
              <a:ext uri="{FF2B5EF4-FFF2-40B4-BE49-F238E27FC236}">
                <a16:creationId xmlns:a16="http://schemas.microsoft.com/office/drawing/2014/main" id="{DFAC3858-6B35-4259-A884-B8BA4A18400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85864" y="3621798"/>
            <a:ext cx="952500" cy="7143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6" descr="C:\Users\USER\CloudStation\project\Thanh\5. PLOS One\erratum\A5(Fc1)10j.jpg">
            <a:extLst>
              <a:ext uri="{FF2B5EF4-FFF2-40B4-BE49-F238E27FC236}">
                <a16:creationId xmlns:a16="http://schemas.microsoft.com/office/drawing/2014/main" id="{84CCAB5E-AEC4-4724-9A38-95C6FBCB39D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85864" y="4407390"/>
            <a:ext cx="952500" cy="7143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직사각형 7">
            <a:extLst>
              <a:ext uri="{FF2B5EF4-FFF2-40B4-BE49-F238E27FC236}">
                <a16:creationId xmlns:a16="http://schemas.microsoft.com/office/drawing/2014/main" id="{6C7F72B4-B6BA-4ED6-8956-16EA3D79AA58}"/>
              </a:ext>
            </a:extLst>
          </p:cNvPr>
          <p:cNvSpPr/>
          <p:nvPr/>
        </p:nvSpPr>
        <p:spPr>
          <a:xfrm>
            <a:off x="2758058" y="4410522"/>
            <a:ext cx="1008112" cy="73608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9" name="Picture 7" descr="C:\Users\USER\CloudStation\project\Thanh\5. PLOS One\erratum\dmso(1)1j.jpg">
            <a:extLst>
              <a:ext uri="{FF2B5EF4-FFF2-40B4-BE49-F238E27FC236}">
                <a16:creationId xmlns:a16="http://schemas.microsoft.com/office/drawing/2014/main" id="{2A54FDF0-C019-466D-B225-8EA5F0D1A8D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colorTemperature colorTemp="112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1834" y="1320300"/>
            <a:ext cx="952500" cy="7143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8" descr="C:\Users\USER\CloudStation\project\Thanh\5. PLOS One\erratum\dmso(1)2j.jpg">
            <a:extLst>
              <a:ext uri="{FF2B5EF4-FFF2-40B4-BE49-F238E27FC236}">
                <a16:creationId xmlns:a16="http://schemas.microsoft.com/office/drawing/2014/main" id="{2948776F-7046-44FB-AE86-44FC9C50548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colorTemperature colorTemp="112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1834" y="2095417"/>
            <a:ext cx="952500" cy="7143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9" descr="C:\Users\USER\CloudStation\project\Thanh\5. PLOS One\erratum\dmso(1)3j.jpg">
            <a:extLst>
              <a:ext uri="{FF2B5EF4-FFF2-40B4-BE49-F238E27FC236}">
                <a16:creationId xmlns:a16="http://schemas.microsoft.com/office/drawing/2014/main" id="{B9345A53-3D99-404F-84AE-716DFD78EB8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colorTemperature colorTemp="112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1834" y="2862838"/>
            <a:ext cx="952500" cy="7143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11" descr="C:\Users\USER\CloudStation\project\Thanh\5. PLOS One\erratum\dmso(1)7j.jpg">
            <a:extLst>
              <a:ext uri="{FF2B5EF4-FFF2-40B4-BE49-F238E27FC236}">
                <a16:creationId xmlns:a16="http://schemas.microsoft.com/office/drawing/2014/main" id="{7BCE15CB-31DB-46A1-AB93-94557F080A3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1834" y="3629290"/>
            <a:ext cx="952500" cy="7143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12" descr="C:\Users\USER\CloudStation\project\Thanh\5. PLOS One\erratum\ua10(1)3j.jpg">
            <a:extLst>
              <a:ext uri="{FF2B5EF4-FFF2-40B4-BE49-F238E27FC236}">
                <a16:creationId xmlns:a16="http://schemas.microsoft.com/office/drawing/2014/main" id="{2866E460-F45B-4678-BDD3-03767520B78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77752" y="1320300"/>
            <a:ext cx="952500" cy="7143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" name="Picture 13" descr="C:\Users\USER\CloudStation\project\Thanh\5. PLOS One\erratum\ua10(1)5j.jpg">
            <a:extLst>
              <a:ext uri="{FF2B5EF4-FFF2-40B4-BE49-F238E27FC236}">
                <a16:creationId xmlns:a16="http://schemas.microsoft.com/office/drawing/2014/main" id="{4EF3EE6A-DECF-4C82-98BF-02DB2B2EB86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77752" y="2095417"/>
            <a:ext cx="952500" cy="7143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Picture 14" descr="C:\Users\USER\CloudStation\project\Thanh\5. PLOS One\erratum\ua10(1)9j.jpg">
            <a:extLst>
              <a:ext uri="{FF2B5EF4-FFF2-40B4-BE49-F238E27FC236}">
                <a16:creationId xmlns:a16="http://schemas.microsoft.com/office/drawing/2014/main" id="{F0887F06-E345-41EB-B066-FAF462762AB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81133" y="2862838"/>
            <a:ext cx="952500" cy="7143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Picture 15" descr="C:\Users\USER\CloudStation\project\Thanh\5. PLOS One\erratum\ua10(2)2j.jpg">
            <a:extLst>
              <a:ext uri="{FF2B5EF4-FFF2-40B4-BE49-F238E27FC236}">
                <a16:creationId xmlns:a16="http://schemas.microsoft.com/office/drawing/2014/main" id="{E36C7697-42F3-4E97-8FE1-8A781229C65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81133" y="3621798"/>
            <a:ext cx="952500" cy="7143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" name="Picture 16" descr="C:\Users\USER\CloudStation\project\Thanh\5. PLOS One\erratum\ua10(2)3j.jpg">
            <a:extLst>
              <a:ext uri="{FF2B5EF4-FFF2-40B4-BE49-F238E27FC236}">
                <a16:creationId xmlns:a16="http://schemas.microsoft.com/office/drawing/2014/main" id="{CE69F06A-9B82-46DC-B58E-70B0D79AB91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81133" y="4407390"/>
            <a:ext cx="952500" cy="7143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" name="Picture 17" descr="C:\Users\USER\CloudStation\project\Thanh\5. PLOS One\erratum\ua10(2)4j.jpg">
            <a:extLst>
              <a:ext uri="{FF2B5EF4-FFF2-40B4-BE49-F238E27FC236}">
                <a16:creationId xmlns:a16="http://schemas.microsoft.com/office/drawing/2014/main" id="{58490B30-CB21-448B-BBC9-E0AC8E2D158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77752" y="5180285"/>
            <a:ext cx="952500" cy="7143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9" name="직사각형 18">
            <a:extLst>
              <a:ext uri="{FF2B5EF4-FFF2-40B4-BE49-F238E27FC236}">
                <a16:creationId xmlns:a16="http://schemas.microsoft.com/office/drawing/2014/main" id="{64A7765A-BC68-4191-8CA5-5BFCCFA3D8C3}"/>
              </a:ext>
            </a:extLst>
          </p:cNvPr>
          <p:cNvSpPr/>
          <p:nvPr/>
        </p:nvSpPr>
        <p:spPr>
          <a:xfrm>
            <a:off x="1749946" y="2084561"/>
            <a:ext cx="1008112" cy="73608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20" name="Picture 18" descr="C:\Users\USER\CloudStation\project\Thanh\5. PLOS One\erratum\lic10(1)4jpgj.jpg">
            <a:extLst>
              <a:ext uri="{FF2B5EF4-FFF2-40B4-BE49-F238E27FC236}">
                <a16:creationId xmlns:a16="http://schemas.microsoft.com/office/drawing/2014/main" id="{8D286249-95FB-4216-A528-3C2A297068F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0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colorTemperature colorTemp="112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93976" y="1320300"/>
            <a:ext cx="952500" cy="7143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" name="Picture 19" descr="C:\Users\USER\CloudStation\project\Thanh\5. PLOS One\erratum\lic10(1)8j.jpg">
            <a:extLst>
              <a:ext uri="{FF2B5EF4-FFF2-40B4-BE49-F238E27FC236}">
                <a16:creationId xmlns:a16="http://schemas.microsoft.com/office/drawing/2014/main" id="{B7FC675B-8E24-494F-A5F0-424E907B967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93976" y="2095417"/>
            <a:ext cx="952500" cy="7143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" name="Picture 20" descr="C:\Users\USER\CloudStation\project\Thanh\5. PLOS One\erratum\lic10(2)3.jpg">
            <a:extLst>
              <a:ext uri="{FF2B5EF4-FFF2-40B4-BE49-F238E27FC236}">
                <a16:creationId xmlns:a16="http://schemas.microsoft.com/office/drawing/2014/main" id="{08F34002-6776-438C-8087-611F21DEC4C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3" cstate="print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89135" y="2862838"/>
            <a:ext cx="955661" cy="7200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" name="Picture 21" descr="C:\Users\USER\CloudStation\project\Thanh\5. PLOS One\erratum\lic10(2)4.jpg">
            <a:extLst>
              <a:ext uri="{FF2B5EF4-FFF2-40B4-BE49-F238E27FC236}">
                <a16:creationId xmlns:a16="http://schemas.microsoft.com/office/drawing/2014/main" id="{C556DEE0-A695-4D07-8A72-CE915D138FF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5" cstate="print">
            <a:extLst>
              <a:ext uri="{BEBA8EAE-BF5A-486C-A8C5-ECC9F3942E4B}">
                <a14:imgProps xmlns:a14="http://schemas.microsoft.com/office/drawing/2010/main">
                  <a14:imgLayer r:embed="rId26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89136" y="3632935"/>
            <a:ext cx="955659" cy="7200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4" name="Picture 22" descr="C:\Users\USER\CloudStation\project\Thanh\5. PLOS One\erratum\lic10(2)5.jpg">
            <a:extLst>
              <a:ext uri="{FF2B5EF4-FFF2-40B4-BE49-F238E27FC236}">
                <a16:creationId xmlns:a16="http://schemas.microsoft.com/office/drawing/2014/main" id="{74F43D17-77BF-4118-98A0-8A23C1488E8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7" cstate="print">
            <a:extLst>
              <a:ext uri="{BEBA8EAE-BF5A-486C-A8C5-ECC9F3942E4B}">
                <a14:imgProps xmlns:a14="http://schemas.microsoft.com/office/drawing/2010/main">
                  <a14:imgLayer r:embed="rId28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89136" y="4407021"/>
            <a:ext cx="952500" cy="71769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5" name="직사각형 24">
            <a:extLst>
              <a:ext uri="{FF2B5EF4-FFF2-40B4-BE49-F238E27FC236}">
                <a16:creationId xmlns:a16="http://schemas.microsoft.com/office/drawing/2014/main" id="{C5A8F174-1292-4E6B-ABD2-97FAA9024940}"/>
              </a:ext>
            </a:extLst>
          </p:cNvPr>
          <p:cNvSpPr/>
          <p:nvPr/>
        </p:nvSpPr>
        <p:spPr>
          <a:xfrm>
            <a:off x="3766170" y="2084561"/>
            <a:ext cx="1008112" cy="73608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6" name="직사각형 25">
            <a:extLst>
              <a:ext uri="{FF2B5EF4-FFF2-40B4-BE49-F238E27FC236}">
                <a16:creationId xmlns:a16="http://schemas.microsoft.com/office/drawing/2014/main" id="{06B4E40B-E3D6-4EFC-AEA6-5C3A401C5617}"/>
              </a:ext>
            </a:extLst>
          </p:cNvPr>
          <p:cNvSpPr/>
          <p:nvPr/>
        </p:nvSpPr>
        <p:spPr>
          <a:xfrm>
            <a:off x="714028" y="3614099"/>
            <a:ext cx="1008112" cy="73608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7" name="타원 26">
            <a:extLst>
              <a:ext uri="{FF2B5EF4-FFF2-40B4-BE49-F238E27FC236}">
                <a16:creationId xmlns:a16="http://schemas.microsoft.com/office/drawing/2014/main" id="{8BCBA619-3BC8-47B0-ACBF-47BD648E7B4B}"/>
              </a:ext>
            </a:extLst>
          </p:cNvPr>
          <p:cNvSpPr/>
          <p:nvPr/>
        </p:nvSpPr>
        <p:spPr>
          <a:xfrm>
            <a:off x="6870137" y="1459498"/>
            <a:ext cx="3571917" cy="3600450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8" name="직사각형 27">
            <a:extLst>
              <a:ext uri="{FF2B5EF4-FFF2-40B4-BE49-F238E27FC236}">
                <a16:creationId xmlns:a16="http://schemas.microsoft.com/office/drawing/2014/main" id="{64FF4E5A-4EE2-41B3-8C6F-F1EAFEA10C3D}"/>
              </a:ext>
            </a:extLst>
          </p:cNvPr>
          <p:cNvSpPr>
            <a:spLocks noChangeAspect="1"/>
          </p:cNvSpPr>
          <p:nvPr/>
        </p:nvSpPr>
        <p:spPr>
          <a:xfrm>
            <a:off x="7310386" y="2097406"/>
            <a:ext cx="1168450" cy="856096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/>
              <a:t>1</a:t>
            </a:r>
            <a:endParaRPr lang="ko-KR" altLang="en-US" dirty="0"/>
          </a:p>
        </p:txBody>
      </p:sp>
      <p:sp>
        <p:nvSpPr>
          <p:cNvPr id="29" name="직사각형 28">
            <a:extLst>
              <a:ext uri="{FF2B5EF4-FFF2-40B4-BE49-F238E27FC236}">
                <a16:creationId xmlns:a16="http://schemas.microsoft.com/office/drawing/2014/main" id="{D3D704F4-B838-4DFA-8E49-02D5A9823F01}"/>
              </a:ext>
            </a:extLst>
          </p:cNvPr>
          <p:cNvSpPr>
            <a:spLocks noChangeAspect="1"/>
          </p:cNvSpPr>
          <p:nvPr/>
        </p:nvSpPr>
        <p:spPr>
          <a:xfrm>
            <a:off x="8862102" y="2097405"/>
            <a:ext cx="1168450" cy="856096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/>
              <a:t>2</a:t>
            </a:r>
            <a:endParaRPr lang="ko-KR" altLang="en-US" dirty="0"/>
          </a:p>
        </p:txBody>
      </p:sp>
      <p:sp>
        <p:nvSpPr>
          <p:cNvPr id="30" name="직사각형 29">
            <a:extLst>
              <a:ext uri="{FF2B5EF4-FFF2-40B4-BE49-F238E27FC236}">
                <a16:creationId xmlns:a16="http://schemas.microsoft.com/office/drawing/2014/main" id="{577AE462-AB1A-4B98-8974-7270533A9B9E}"/>
              </a:ext>
            </a:extLst>
          </p:cNvPr>
          <p:cNvSpPr>
            <a:spLocks noChangeAspect="1"/>
          </p:cNvSpPr>
          <p:nvPr/>
        </p:nvSpPr>
        <p:spPr>
          <a:xfrm>
            <a:off x="7310386" y="3578677"/>
            <a:ext cx="1168450" cy="856096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/>
              <a:t>4</a:t>
            </a:r>
            <a:endParaRPr lang="ko-KR" altLang="en-US" dirty="0"/>
          </a:p>
        </p:txBody>
      </p:sp>
      <p:sp>
        <p:nvSpPr>
          <p:cNvPr id="31" name="직사각형 30">
            <a:extLst>
              <a:ext uri="{FF2B5EF4-FFF2-40B4-BE49-F238E27FC236}">
                <a16:creationId xmlns:a16="http://schemas.microsoft.com/office/drawing/2014/main" id="{F97FB201-66D4-46E5-8F43-4530053E6ECC}"/>
              </a:ext>
            </a:extLst>
          </p:cNvPr>
          <p:cNvSpPr>
            <a:spLocks noChangeAspect="1"/>
          </p:cNvSpPr>
          <p:nvPr/>
        </p:nvSpPr>
        <p:spPr>
          <a:xfrm>
            <a:off x="8860257" y="3607268"/>
            <a:ext cx="1168450" cy="856096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/>
              <a:t>5</a:t>
            </a:r>
            <a:endParaRPr lang="ko-KR" altLang="en-US" dirty="0"/>
          </a:p>
        </p:txBody>
      </p:sp>
      <p:sp>
        <p:nvSpPr>
          <p:cNvPr id="32" name="직사각형 31">
            <a:extLst>
              <a:ext uri="{FF2B5EF4-FFF2-40B4-BE49-F238E27FC236}">
                <a16:creationId xmlns:a16="http://schemas.microsoft.com/office/drawing/2014/main" id="{E9D0478C-C61A-4450-9350-D0201C290DF5}"/>
              </a:ext>
            </a:extLst>
          </p:cNvPr>
          <p:cNvSpPr>
            <a:spLocks noChangeAspect="1"/>
          </p:cNvSpPr>
          <p:nvPr/>
        </p:nvSpPr>
        <p:spPr>
          <a:xfrm>
            <a:off x="8100362" y="2838041"/>
            <a:ext cx="1168450" cy="856096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dirty="0"/>
              <a:t>3</a:t>
            </a:r>
            <a:endParaRPr lang="ko-KR" altLang="en-US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C205FE6B-CF90-438D-815F-9C7F5A5AEB6F}"/>
              </a:ext>
            </a:extLst>
          </p:cNvPr>
          <p:cNvSpPr txBox="1"/>
          <p:nvPr/>
        </p:nvSpPr>
        <p:spPr>
          <a:xfrm>
            <a:off x="7593930" y="970145"/>
            <a:ext cx="21158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err="1"/>
              <a:t>Transwell</a:t>
            </a:r>
            <a:r>
              <a:rPr lang="en-US" altLang="ko-KR" dirty="0"/>
              <a:t> chamber</a:t>
            </a:r>
            <a:endParaRPr lang="ko-KR" altLang="en-US" dirty="0"/>
          </a:p>
        </p:txBody>
      </p:sp>
      <p:pic>
        <p:nvPicPr>
          <p:cNvPr id="34" name="Picture 10" descr="C:\Users\USER\CloudStation\project\Thanh\5. PLOS One\erratum\dmso(1)6j.jpg">
            <a:extLst>
              <a:ext uri="{FF2B5EF4-FFF2-40B4-BE49-F238E27FC236}">
                <a16:creationId xmlns:a16="http://schemas.microsoft.com/office/drawing/2014/main" id="{F34B34F2-300D-4A9F-8C7B-A4EB96D5D24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89135" y="5180285"/>
            <a:ext cx="952500" cy="7143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36" name="직선 화살표 연결선 35">
            <a:extLst>
              <a:ext uri="{FF2B5EF4-FFF2-40B4-BE49-F238E27FC236}">
                <a16:creationId xmlns:a16="http://schemas.microsoft.com/office/drawing/2014/main" id="{5725B335-73D3-4580-9B88-45570B2291D7}"/>
              </a:ext>
            </a:extLst>
          </p:cNvPr>
          <p:cNvCxnSpPr/>
          <p:nvPr/>
        </p:nvCxnSpPr>
        <p:spPr>
          <a:xfrm>
            <a:off x="4441371" y="5646057"/>
            <a:ext cx="595086" cy="24860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C30D6B3A-8AC0-4D89-AF31-5A2073559AD9}"/>
              </a:ext>
            </a:extLst>
          </p:cNvPr>
          <p:cNvSpPr txBox="1"/>
          <p:nvPr/>
        </p:nvSpPr>
        <p:spPr>
          <a:xfrm>
            <a:off x="5283200" y="5894660"/>
            <a:ext cx="6761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Mistakenly displayed as DMSO, AGS panel in published Fig 6D.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4489090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7</Words>
  <Application>Microsoft Office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aya Reik</dc:creator>
  <cp:lastModifiedBy>Amaya Reik</cp:lastModifiedBy>
  <cp:revision>1</cp:revision>
  <dcterms:created xsi:type="dcterms:W3CDTF">2023-02-16T15:37:22Z</dcterms:created>
  <dcterms:modified xsi:type="dcterms:W3CDTF">2023-02-16T15:40:05Z</dcterms:modified>
</cp:coreProperties>
</file>